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160" d="100"/>
          <a:sy n="160" d="100"/>
        </p:scale>
        <p:origin x="26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5D583-E719-D936-2A26-BBD1096FE2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3BCE30E-BF7E-631A-0569-CF56F646EE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FED939-CC30-914D-71FD-544613250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C9ACC2-F5C6-A176-71CC-58B43F50E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05C8F0-A712-8F26-17A7-DD4C6EE78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2616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0A4B20-943A-26F1-597D-D837045E3F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D8EDB4-D8AF-ADFF-142E-3450BB881A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A20C82-691D-621E-9590-CC39FCC1D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E3B99E-D4C2-C3ED-14F4-3D5F48D6F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0D6AF3-F476-9BF9-E2CA-12A3399C5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27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F11C6F-B329-D9E8-EEAC-4BA4541D12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30DBC9-4727-87D5-F80A-3FAB928EE7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3290D4-EC61-3828-374C-210BE2947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902C88-B6CC-7578-5B53-D2DD1B700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7694DC-5E9A-CF51-FD9E-1344EFFE2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524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AAABEC-1D80-160F-A9BD-1472CC4193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890F56-FA1F-FABF-736C-891CE3593C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E19DFF-B3A1-FD6F-17D2-6436F014D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3E3368-EFEF-DB62-997F-F0C145A78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5631A4-87A3-D011-872B-7567B12D8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7497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3BE30-C5A9-3656-8AC5-09D1C28B47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DF0E09-D456-AC3D-B970-83C0400C7F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562571-7125-1BF0-08AB-2B595C515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7ED117-FFA6-3F40-3976-8D52BA3BE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3D47D9-F745-0D1C-99B3-3E4538AB1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666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721C31-A034-2C49-74F6-B8470FA2AC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6764E7-D882-FFED-C21B-8D509589DA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769107-4CE5-557E-80CD-6BF0C90A8E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3B8B4B-0819-7081-8CAE-1CDCA7A75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F6BFE4-9589-CDD7-61AD-83DD23FCA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84E9D0-7D8D-0353-689A-87AC7E186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288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E031E2-917E-17F0-B1AE-5A1DFD7A32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ECF426-FD17-43DB-AF74-20F2FA26D6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25297F-A0E0-489B-2BC8-720C039824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E624F8-9E93-2104-3044-7192DF410D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E839A38-110F-462B-E7DE-A3C0C6E7F7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B8322F-5351-4202-0C8D-96D970398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DC5C2F-4C73-35B0-D5BF-3CCF588F8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3CF390-23FC-4BA6-28D0-1880AE76D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228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C06F5E-18D1-C822-4B1A-32BE92D701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28C4D9D-BE90-B968-3151-68439E58E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801E55-765D-4023-E7C0-C89453064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BAF32A-0937-70A5-954D-A315D1D1D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2217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E2D18F-2A1A-0936-4198-848B26106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557EDF-BD6C-F64B-E9D8-D3FFF3B248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9C93EF2-3351-2C38-6E57-D3322EF49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4823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F58FB2-1179-C22C-541C-B258B1917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09E09A-F896-C4E7-F69D-8252F0A4AA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A1E866-6ECF-12A4-41BC-751A48CFEB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DAE4F9-197D-8B39-10D9-B508E75A9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F87F2C-FDC7-FF58-C0C1-BEB69C4E64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25389F-ABB0-6AA7-9261-D27FF5DD6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5061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29C5C4-B5ED-3FAF-5813-E524219016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2D2611-8CA0-FF87-D45B-FDD8BB5F65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B863DE-4891-5AD5-3A4B-DAEBE49AD1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D34DE2-8645-994E-C74B-E07FD845B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4F3C6C-5454-0AE5-15A2-54BA8D726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137459-5969-84AE-DCE3-A123A9F91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7475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647E70-830D-B723-B63C-ED10FA19EA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5C349D-E233-C312-328A-7E061FE48B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E2855-465A-FCA9-C502-4CEB201393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74C0D2-587B-435B-BC1E-197A7E514FF7}" type="datetimeFigureOut">
              <a:rPr lang="en-GB" smtClean="0"/>
              <a:t>06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082A11-26E0-DF09-7F8D-FD04496D5B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8D0A74-A5DD-D6FF-87EF-C5B2461A14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B21AA-FBEF-42F2-BDA1-151F321BDF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3258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>
            <a:extLst>
              <a:ext uri="{FF2B5EF4-FFF2-40B4-BE49-F238E27FC236}">
                <a16:creationId xmlns:a16="http://schemas.microsoft.com/office/drawing/2014/main" id="{26F5431E-07A9-D9B5-2D4A-B1DF48F65F76}"/>
              </a:ext>
            </a:extLst>
          </p:cNvPr>
          <p:cNvGrpSpPr/>
          <p:nvPr/>
        </p:nvGrpSpPr>
        <p:grpSpPr>
          <a:xfrm>
            <a:off x="2221392" y="2438394"/>
            <a:ext cx="5313978" cy="2835442"/>
            <a:chOff x="2221392" y="2438394"/>
            <a:chExt cx="5313978" cy="2835442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986831E1-3F75-2859-04FF-2808616C9200}"/>
                </a:ext>
              </a:extLst>
            </p:cNvPr>
            <p:cNvGrpSpPr/>
            <p:nvPr/>
          </p:nvGrpSpPr>
          <p:grpSpPr>
            <a:xfrm>
              <a:off x="2221392" y="3560925"/>
              <a:ext cx="1197144" cy="957275"/>
              <a:chOff x="2221392" y="2748129"/>
              <a:chExt cx="1197144" cy="957275"/>
            </a:xfrm>
          </p:grpSpPr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24477E8A-7200-406E-301A-661001BBD534}"/>
                  </a:ext>
                </a:extLst>
              </p:cNvPr>
              <p:cNvSpPr/>
              <p:nvPr/>
            </p:nvSpPr>
            <p:spPr>
              <a:xfrm>
                <a:off x="2266896" y="2748129"/>
                <a:ext cx="1151640" cy="95727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3D804843-A0CA-594F-D862-6916C98F844D}"/>
                  </a:ext>
                </a:extLst>
              </p:cNvPr>
              <p:cNvSpPr txBox="1"/>
              <p:nvPr/>
            </p:nvSpPr>
            <p:spPr>
              <a:xfrm>
                <a:off x="2221392" y="2748129"/>
                <a:ext cx="1130438" cy="6155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 err="1"/>
                  <a:t>makeblastdb</a:t>
                </a:r>
                <a:br>
                  <a:rPr lang="en-GB" sz="900" dirty="0"/>
                </a:br>
                <a:br>
                  <a:rPr lang="en-GB" sz="900" dirty="0"/>
                </a:br>
                <a:r>
                  <a:rPr lang="en-GB" sz="800" dirty="0"/>
                  <a:t>Create blast databases</a:t>
                </a:r>
                <a:br>
                  <a:rPr lang="en-GB" sz="800" dirty="0"/>
                </a:br>
                <a:r>
                  <a:rPr lang="en-GB" sz="800" dirty="0"/>
                  <a:t>from reference </a:t>
                </a:r>
                <a:r>
                  <a:rPr lang="en-GB" sz="800" dirty="0" err="1"/>
                  <a:t>seqs</a:t>
                </a:r>
                <a:endParaRPr lang="en-GB" sz="1050" dirty="0"/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969B2540-10C7-BB70-370B-96E3919FB9C1}"/>
                </a:ext>
              </a:extLst>
            </p:cNvPr>
            <p:cNvGrpSpPr/>
            <p:nvPr/>
          </p:nvGrpSpPr>
          <p:grpSpPr>
            <a:xfrm>
              <a:off x="3614181" y="3560925"/>
              <a:ext cx="1197144" cy="957275"/>
              <a:chOff x="3581039" y="2748129"/>
              <a:chExt cx="1197144" cy="957275"/>
            </a:xfrm>
          </p:grpSpPr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8EC65055-35A7-42CE-FADB-F5FF54C9499D}"/>
                  </a:ext>
                </a:extLst>
              </p:cNvPr>
              <p:cNvSpPr/>
              <p:nvPr/>
            </p:nvSpPr>
            <p:spPr>
              <a:xfrm>
                <a:off x="3626543" y="2748129"/>
                <a:ext cx="1151640" cy="95727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72949EC-5213-44C3-1425-09490EA32506}"/>
                  </a:ext>
                </a:extLst>
              </p:cNvPr>
              <p:cNvSpPr txBox="1"/>
              <p:nvPr/>
            </p:nvSpPr>
            <p:spPr>
              <a:xfrm>
                <a:off x="3581039" y="2748129"/>
                <a:ext cx="1037463" cy="6155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 err="1"/>
                  <a:t>blastn</a:t>
                </a:r>
                <a:br>
                  <a:rPr lang="en-GB" sz="900" dirty="0"/>
                </a:br>
                <a:br>
                  <a:rPr lang="en-GB" sz="900" dirty="0"/>
                </a:br>
                <a:r>
                  <a:rPr lang="en-GB" sz="800" dirty="0"/>
                  <a:t>Search the assembly</a:t>
                </a:r>
                <a:br>
                  <a:rPr lang="en-GB" sz="800" dirty="0"/>
                </a:br>
                <a:r>
                  <a:rPr lang="en-GB" sz="800" dirty="0"/>
                  <a:t>for matches</a:t>
                </a:r>
                <a:endParaRPr lang="en-GB" sz="1050" dirty="0"/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B8AF3952-CDC5-263F-CA46-380351835A82}"/>
                </a:ext>
              </a:extLst>
            </p:cNvPr>
            <p:cNvGrpSpPr/>
            <p:nvPr/>
          </p:nvGrpSpPr>
          <p:grpSpPr>
            <a:xfrm>
              <a:off x="4961466" y="3560925"/>
              <a:ext cx="1197144" cy="957275"/>
              <a:chOff x="4932308" y="2748129"/>
              <a:chExt cx="1197144" cy="957275"/>
            </a:xfrm>
          </p:grpSpPr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88A278F3-85D2-AD58-A608-1BD68A59AC02}"/>
                  </a:ext>
                </a:extLst>
              </p:cNvPr>
              <p:cNvSpPr/>
              <p:nvPr/>
            </p:nvSpPr>
            <p:spPr>
              <a:xfrm>
                <a:off x="4977812" y="2748129"/>
                <a:ext cx="1151640" cy="95727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80A9FB2-2A1B-85D8-6BFC-134B7F2ACDC7}"/>
                  </a:ext>
                </a:extLst>
              </p:cNvPr>
              <p:cNvSpPr txBox="1"/>
              <p:nvPr/>
            </p:nvSpPr>
            <p:spPr>
              <a:xfrm>
                <a:off x="4932308" y="2748129"/>
                <a:ext cx="1111202" cy="7386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 err="1"/>
                  <a:t>blastresults_to_csv</a:t>
                </a:r>
                <a:br>
                  <a:rPr lang="en-GB" sz="900" dirty="0"/>
                </a:br>
                <a:br>
                  <a:rPr lang="en-GB" sz="900" dirty="0"/>
                </a:br>
                <a:r>
                  <a:rPr lang="en-GB" sz="800" dirty="0"/>
                  <a:t>Convert results to one</a:t>
                </a:r>
                <a:br>
                  <a:rPr lang="en-GB" sz="800" dirty="0"/>
                </a:br>
                <a:r>
                  <a:rPr lang="en-GB" sz="800" dirty="0"/>
                  <a:t>file per assembly</a:t>
                </a:r>
                <a:br>
                  <a:rPr lang="en-GB" sz="800" dirty="0"/>
                </a:br>
                <a:r>
                  <a:rPr lang="en-GB" sz="800" dirty="0"/>
                  <a:t>sequence</a:t>
                </a:r>
                <a:endParaRPr lang="en-GB" sz="1050" dirty="0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E954ECDE-02D7-7E5F-3528-476AF0971037}"/>
                </a:ext>
              </a:extLst>
            </p:cNvPr>
            <p:cNvGrpSpPr/>
            <p:nvPr/>
          </p:nvGrpSpPr>
          <p:grpSpPr>
            <a:xfrm>
              <a:off x="6338226" y="3560925"/>
              <a:ext cx="1197144" cy="957275"/>
              <a:chOff x="6338226" y="2748129"/>
              <a:chExt cx="1197144" cy="957275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26B0B49B-9EE6-A959-1124-9D060125E539}"/>
                  </a:ext>
                </a:extLst>
              </p:cNvPr>
              <p:cNvSpPr/>
              <p:nvPr/>
            </p:nvSpPr>
            <p:spPr>
              <a:xfrm>
                <a:off x="6383730" y="2748129"/>
                <a:ext cx="1151640" cy="95727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4FE323F3-C265-0397-A1F1-8E6A9B6B4E35}"/>
                  </a:ext>
                </a:extLst>
              </p:cNvPr>
              <p:cNvSpPr txBox="1"/>
              <p:nvPr/>
            </p:nvSpPr>
            <p:spPr>
              <a:xfrm>
                <a:off x="6338226" y="2748129"/>
                <a:ext cx="1116011" cy="8617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b="1" dirty="0" err="1"/>
                  <a:t>find_alignments</a:t>
                </a:r>
                <a:br>
                  <a:rPr lang="en-GB" sz="900" dirty="0"/>
                </a:br>
                <a:br>
                  <a:rPr lang="en-GB" sz="900" dirty="0"/>
                </a:br>
                <a:r>
                  <a:rPr lang="en-GB" sz="800" dirty="0"/>
                  <a:t>Annotate alignments</a:t>
                </a:r>
                <a:br>
                  <a:rPr lang="en-GB" sz="800" dirty="0"/>
                </a:br>
                <a:r>
                  <a:rPr lang="en-GB" sz="800" dirty="0"/>
                  <a:t>in the assembly, </a:t>
                </a:r>
                <a:br>
                  <a:rPr lang="en-GB" sz="800" dirty="0"/>
                </a:br>
                <a:r>
                  <a:rPr lang="en-GB" sz="800" dirty="0"/>
                  <a:t>guided by blast search</a:t>
                </a:r>
                <a:br>
                  <a:rPr lang="en-GB" sz="800" dirty="0"/>
                </a:br>
                <a:r>
                  <a:rPr lang="en-GB" sz="800" dirty="0"/>
                  <a:t>results</a:t>
                </a:r>
                <a:endParaRPr lang="en-GB" sz="1050" dirty="0"/>
              </a:p>
            </p:txBody>
          </p:sp>
        </p:grpSp>
        <p:sp>
          <p:nvSpPr>
            <p:cNvPr id="12" name="Cylinder 11">
              <a:extLst>
                <a:ext uri="{FF2B5EF4-FFF2-40B4-BE49-F238E27FC236}">
                  <a16:creationId xmlns:a16="http://schemas.microsoft.com/office/drawing/2014/main" id="{E08D5E7D-5AFC-CC65-EF6A-01BDE6ADC7B7}"/>
                </a:ext>
              </a:extLst>
            </p:cNvPr>
            <p:cNvSpPr/>
            <p:nvPr/>
          </p:nvSpPr>
          <p:spPr>
            <a:xfrm>
              <a:off x="4267820" y="2438394"/>
              <a:ext cx="609600" cy="639482"/>
            </a:xfrm>
            <a:prstGeom prst="can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dirty="0">
                  <a:solidFill>
                    <a:schemeClr val="tx1"/>
                  </a:solidFill>
                </a:rPr>
                <a:t>germline</a:t>
              </a:r>
              <a:br>
                <a:rPr lang="en-GB" sz="800" dirty="0">
                  <a:solidFill>
                    <a:schemeClr val="tx1"/>
                  </a:solidFill>
                </a:rPr>
              </a:br>
              <a:r>
                <a:rPr lang="en-GB" sz="800" dirty="0">
                  <a:solidFill>
                    <a:schemeClr val="tx1"/>
                  </a:solidFill>
                </a:rPr>
                <a:t>reference</a:t>
              </a:r>
              <a:br>
                <a:rPr lang="en-GB" sz="800" dirty="0">
                  <a:solidFill>
                    <a:schemeClr val="tx1"/>
                  </a:solidFill>
                </a:rPr>
              </a:br>
              <a:r>
                <a:rPr lang="en-GB" sz="800" dirty="0">
                  <a:solidFill>
                    <a:schemeClr val="tx1"/>
                  </a:solidFill>
                </a:rPr>
                <a:t>set</a:t>
              </a:r>
              <a:endParaRPr lang="en-GB" sz="900" dirty="0">
                <a:solidFill>
                  <a:schemeClr val="tx1"/>
                </a:solidFill>
              </a:endParaRPr>
            </a:p>
          </p:txBody>
        </p:sp>
        <p:sp>
          <p:nvSpPr>
            <p:cNvPr id="13" name="Cylinder 12">
              <a:extLst>
                <a:ext uri="{FF2B5EF4-FFF2-40B4-BE49-F238E27FC236}">
                  <a16:creationId xmlns:a16="http://schemas.microsoft.com/office/drawing/2014/main" id="{0E4F4FA7-AAA4-4A73-CAAB-EBB53D703AE7}"/>
                </a:ext>
              </a:extLst>
            </p:cNvPr>
            <p:cNvSpPr/>
            <p:nvPr/>
          </p:nvSpPr>
          <p:spPr>
            <a:xfrm>
              <a:off x="5192957" y="2438394"/>
              <a:ext cx="609600" cy="639482"/>
            </a:xfrm>
            <a:prstGeom prst="can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dirty="0">
                  <a:solidFill>
                    <a:schemeClr val="tx1"/>
                  </a:solidFill>
                </a:rPr>
                <a:t>assembly</a:t>
              </a:r>
              <a:br>
                <a:rPr lang="en-GB" sz="800" dirty="0">
                  <a:solidFill>
                    <a:schemeClr val="tx1"/>
                  </a:solidFill>
                </a:rPr>
              </a:br>
              <a:r>
                <a:rPr lang="en-GB" sz="800" dirty="0">
                  <a:solidFill>
                    <a:schemeClr val="tx1"/>
                  </a:solidFill>
                </a:rPr>
                <a:t>sequence</a:t>
              </a:r>
              <a:endParaRPr lang="en-GB" sz="900" dirty="0">
                <a:solidFill>
                  <a:schemeClr val="tx1"/>
                </a:solidFill>
              </a:endParaRP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0BF99368-15DC-F9DA-A153-F0780EEC7092}"/>
                </a:ext>
              </a:extLst>
            </p:cNvPr>
            <p:cNvCxnSpPr>
              <a:cxnSpLocks/>
            </p:cNvCxnSpPr>
            <p:nvPr/>
          </p:nvCxnSpPr>
          <p:spPr>
            <a:xfrm>
              <a:off x="3418536" y="4039562"/>
              <a:ext cx="2411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BDEE816B-6B72-30AA-BD42-073ADABC1A82}"/>
                </a:ext>
              </a:extLst>
            </p:cNvPr>
            <p:cNvCxnSpPr>
              <a:cxnSpLocks/>
            </p:cNvCxnSpPr>
            <p:nvPr/>
          </p:nvCxnSpPr>
          <p:spPr>
            <a:xfrm>
              <a:off x="4799239" y="4039562"/>
              <a:ext cx="20773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0629F0B8-FC36-2FD1-74B0-C8E834A7E9D2}"/>
                </a:ext>
              </a:extLst>
            </p:cNvPr>
            <p:cNvCxnSpPr>
              <a:cxnSpLocks/>
            </p:cNvCxnSpPr>
            <p:nvPr/>
          </p:nvCxnSpPr>
          <p:spPr>
            <a:xfrm>
              <a:off x="6158610" y="4039562"/>
              <a:ext cx="2411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163F757A-2F47-57FE-0D72-6F9D41F6D9F7}"/>
                </a:ext>
              </a:extLst>
            </p:cNvPr>
            <p:cNvCxnSpPr>
              <a:stCxn id="12" idx="3"/>
              <a:endCxn id="5" idx="0"/>
            </p:cNvCxnSpPr>
            <p:nvPr/>
          </p:nvCxnSpPr>
          <p:spPr>
            <a:xfrm flipH="1">
              <a:off x="2786611" y="3077876"/>
              <a:ext cx="1786009" cy="4830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5F6E24B2-7532-5C73-BCE9-6C4D776800C4}"/>
                </a:ext>
              </a:extLst>
            </p:cNvPr>
            <p:cNvCxnSpPr>
              <a:stCxn id="12" idx="3"/>
              <a:endCxn id="11" idx="0"/>
            </p:cNvCxnSpPr>
            <p:nvPr/>
          </p:nvCxnSpPr>
          <p:spPr>
            <a:xfrm>
              <a:off x="4572620" y="3077876"/>
              <a:ext cx="2323612" cy="4830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DC092D14-9F60-52DF-4BB4-8FE6F08FBE64}"/>
                </a:ext>
              </a:extLst>
            </p:cNvPr>
            <p:cNvCxnSpPr>
              <a:stCxn id="13" idx="3"/>
              <a:endCxn id="7" idx="0"/>
            </p:cNvCxnSpPr>
            <p:nvPr/>
          </p:nvCxnSpPr>
          <p:spPr>
            <a:xfrm flipH="1">
              <a:off x="4132913" y="3077876"/>
              <a:ext cx="1364844" cy="4830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29EF136A-81DA-2D66-9123-9044BD1CCE27}"/>
                </a:ext>
              </a:extLst>
            </p:cNvPr>
            <p:cNvCxnSpPr>
              <a:stCxn id="13" idx="3"/>
              <a:endCxn id="11" idx="0"/>
            </p:cNvCxnSpPr>
            <p:nvPr/>
          </p:nvCxnSpPr>
          <p:spPr>
            <a:xfrm>
              <a:off x="5497757" y="3077876"/>
              <a:ext cx="1398475" cy="4830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Cylinder 59">
              <a:extLst>
                <a:ext uri="{FF2B5EF4-FFF2-40B4-BE49-F238E27FC236}">
                  <a16:creationId xmlns:a16="http://schemas.microsoft.com/office/drawing/2014/main" id="{723FC6D6-199D-A7A6-03A5-984233778D9C}"/>
                </a:ext>
              </a:extLst>
            </p:cNvPr>
            <p:cNvSpPr/>
            <p:nvPr/>
          </p:nvSpPr>
          <p:spPr>
            <a:xfrm>
              <a:off x="6603999" y="2438394"/>
              <a:ext cx="653939" cy="639482"/>
            </a:xfrm>
            <a:prstGeom prst="can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800" dirty="0">
                  <a:solidFill>
                    <a:schemeClr val="tx1"/>
                  </a:solidFill>
                </a:rPr>
                <a:t>leader/RSS</a:t>
              </a:r>
              <a:br>
                <a:rPr lang="en-GB" sz="800" dirty="0">
                  <a:solidFill>
                    <a:schemeClr val="tx1"/>
                  </a:solidFill>
                </a:rPr>
              </a:br>
              <a:r>
                <a:rPr lang="en-GB" sz="800" dirty="0">
                  <a:solidFill>
                    <a:schemeClr val="tx1"/>
                  </a:solidFill>
                </a:rPr>
                <a:t>motifs</a:t>
              </a:r>
              <a:endParaRPr lang="en-GB" sz="900" dirty="0">
                <a:solidFill>
                  <a:schemeClr val="tx1"/>
                </a:solidFill>
              </a:endParaRPr>
            </a:p>
          </p:txBody>
        </p: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C7000370-B2BE-51C2-5AA9-B797F1ED495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20136" y="3077876"/>
              <a:ext cx="0" cy="4830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Right Brace 65">
              <a:extLst>
                <a:ext uri="{FF2B5EF4-FFF2-40B4-BE49-F238E27FC236}">
                  <a16:creationId xmlns:a16="http://schemas.microsoft.com/office/drawing/2014/main" id="{415D6718-4DBB-3AF3-DA2D-7227529C9791}"/>
                </a:ext>
              </a:extLst>
            </p:cNvPr>
            <p:cNvSpPr/>
            <p:nvPr/>
          </p:nvSpPr>
          <p:spPr>
            <a:xfrm rot="5400000">
              <a:off x="4713520" y="2224494"/>
              <a:ext cx="327798" cy="5055187"/>
            </a:xfrm>
            <a:prstGeom prst="rightBrace">
              <a:avLst>
                <a:gd name="adj1" fmla="val 8333"/>
                <a:gd name="adj2" fmla="val 49764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97E1BFD-77E4-DC50-48EB-64C03778880B}"/>
                </a:ext>
              </a:extLst>
            </p:cNvPr>
            <p:cNvSpPr txBox="1"/>
            <p:nvPr/>
          </p:nvSpPr>
          <p:spPr>
            <a:xfrm>
              <a:off x="3181318" y="5019920"/>
              <a:ext cx="344357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Individual steps are managed by digger for typical use cases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457603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78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 Lees</dc:creator>
  <cp:lastModifiedBy>William Lees</cp:lastModifiedBy>
  <cp:revision>3</cp:revision>
  <dcterms:created xsi:type="dcterms:W3CDTF">2023-04-06T09:46:17Z</dcterms:created>
  <dcterms:modified xsi:type="dcterms:W3CDTF">2023-04-06T10:15:31Z</dcterms:modified>
</cp:coreProperties>
</file>